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098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3732" y="656133"/>
            <a:ext cx="2016223" cy="1909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1900" y="663657"/>
            <a:ext cx="1976288" cy="19024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132" y="663657"/>
            <a:ext cx="1976288" cy="18935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331" y="2703425"/>
            <a:ext cx="1947707" cy="18956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6" y="666248"/>
            <a:ext cx="1979248" cy="1882067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29" name="Rechteck 28"/>
          <p:cNvSpPr/>
          <p:nvPr/>
        </p:nvSpPr>
        <p:spPr>
          <a:xfrm>
            <a:off x="3450951" y="2755996"/>
            <a:ext cx="432048" cy="168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Rechteck 29"/>
          <p:cNvSpPr/>
          <p:nvPr/>
        </p:nvSpPr>
        <p:spPr>
          <a:xfrm>
            <a:off x="3450958" y="4793593"/>
            <a:ext cx="432048" cy="1686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3668" y="2703425"/>
            <a:ext cx="1952615" cy="18867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9854" y="2689974"/>
            <a:ext cx="1961559" cy="19090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6551" y="2684975"/>
            <a:ext cx="1959991" cy="19052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768" y="4760047"/>
            <a:ext cx="1960017" cy="18897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8894" y="4715659"/>
            <a:ext cx="1948511" cy="19252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997" y="4742290"/>
            <a:ext cx="1941416" cy="1880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2886" y="4741565"/>
            <a:ext cx="1974780" cy="1912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feld 11"/>
          <p:cNvSpPr txBox="1"/>
          <p:nvPr/>
        </p:nvSpPr>
        <p:spPr>
          <a:xfrm>
            <a:off x="679144" y="739478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1-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722488" y="723202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6-1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851649" y="735761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11-15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6930503" y="728363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16-20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679143" y="2755996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21-25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2749119" y="2757476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26-30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4845729" y="2758955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31-35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6930503" y="2755996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36-40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682103" y="4817095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41-45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2749119" y="4791169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46-50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4863484" y="4819282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51-55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6930502" y="4819282"/>
            <a:ext cx="17242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56-60                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3203361" y="6654552"/>
            <a:ext cx="33843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 rot="16200000">
            <a:off x="-1505763" y="3492553"/>
            <a:ext cx="3457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peracilli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mg/L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70992" y="7778"/>
            <a:ext cx="9073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2456263" y="411635"/>
            <a:ext cx="16086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econd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number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4115486" y="412407"/>
            <a:ext cx="16086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hird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number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pic>
        <p:nvPicPr>
          <p:cNvPr id="33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2" t="61276" r="57592" b="34345"/>
          <a:stretch/>
        </p:blipFill>
        <p:spPr bwMode="auto">
          <a:xfrm>
            <a:off x="2212621" y="483643"/>
            <a:ext cx="257452" cy="1597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94" t="64475" r="65361" b="31139"/>
          <a:stretch/>
        </p:blipFill>
        <p:spPr bwMode="auto">
          <a:xfrm>
            <a:off x="685694" y="476027"/>
            <a:ext cx="217006" cy="1647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96" t="82976" r="57585" b="12528"/>
          <a:stretch/>
        </p:blipFill>
        <p:spPr bwMode="auto">
          <a:xfrm>
            <a:off x="3899462" y="465553"/>
            <a:ext cx="217790" cy="1640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feld 35"/>
          <p:cNvSpPr txBox="1"/>
          <p:nvPr/>
        </p:nvSpPr>
        <p:spPr>
          <a:xfrm>
            <a:off x="890825" y="410397"/>
            <a:ext cx="16086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irst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5655117" y="410397"/>
            <a:ext cx="16086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urt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number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pic>
        <p:nvPicPr>
          <p:cNvPr id="38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96" t="53288" r="61531" b="41603"/>
          <a:stretch/>
        </p:blipFill>
        <p:spPr bwMode="auto">
          <a:xfrm>
            <a:off x="5435225" y="468718"/>
            <a:ext cx="219953" cy="1864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61" t="79926" r="36458" b="16182"/>
          <a:stretch/>
        </p:blipFill>
        <p:spPr bwMode="auto">
          <a:xfrm>
            <a:off x="7056768" y="480043"/>
            <a:ext cx="204187" cy="142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3" name="Textfeld 52"/>
          <p:cNvSpPr txBox="1"/>
          <p:nvPr/>
        </p:nvSpPr>
        <p:spPr>
          <a:xfrm>
            <a:off x="7308304" y="406839"/>
            <a:ext cx="16086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ft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79219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Bildschirmpräsentation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ander, Johannes  Dr.med.</dc:creator>
  <cp:lastModifiedBy>jzander</cp:lastModifiedBy>
  <cp:revision>14</cp:revision>
  <dcterms:created xsi:type="dcterms:W3CDTF">2015-07-24T11:09:26Z</dcterms:created>
  <dcterms:modified xsi:type="dcterms:W3CDTF">2016-01-15T09:48:37Z</dcterms:modified>
</cp:coreProperties>
</file>